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1" r:id="rId4"/>
    <p:sldId id="258" r:id="rId5"/>
    <p:sldId id="260" r:id="rId6"/>
    <p:sldId id="262" r:id="rId7"/>
    <p:sldId id="263" r:id="rId8"/>
    <p:sldId id="264" r:id="rId9"/>
    <p:sldId id="265" r:id="rId10"/>
    <p:sldId id="266" r:id="rId1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6" d="100"/>
          <a:sy n="56" d="100"/>
        </p:scale>
        <p:origin x="97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CF0EB67-A097-45FD-BF20-7BA636C586C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CE0F7FC-41EA-46FC-9373-276B409AB08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BA350AD-24EC-45B4-A3BE-E6F1D34EB8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D0C03-20F1-4EB4-836C-C2D697AD3255}" type="datetimeFigureOut">
              <a:rPr lang="zh-CN" altLang="en-US" smtClean="0"/>
              <a:t>2020/1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5E89610-0CFA-404F-A14C-328AC771ED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D4E5617-092D-4E78-AB64-F427EF146F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A8E92-9965-4940-924C-B83ED1544D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5091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5DFA209-759D-416B-A1BA-4E065290B1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EAAC841-1ECE-4897-9482-5DA1F3FB16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37ECE8A-3094-4341-9778-F2F3DAFBB5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D0C03-20F1-4EB4-836C-C2D697AD3255}" type="datetimeFigureOut">
              <a:rPr lang="zh-CN" altLang="en-US" smtClean="0"/>
              <a:t>2020/1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0D49989-120B-4022-8A0A-AF3EAD7C6E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D0E2ED3-E485-42B1-8C35-CC5D6FDAEE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A8E92-9965-4940-924C-B83ED1544D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46764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E08D68C-A96A-448B-A710-E6F30EDB17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F75EA5A-1516-434A-BF18-4B80ADBFC0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BBF8558-75C1-4CF7-92B1-B3B0B51C7D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D0C03-20F1-4EB4-836C-C2D697AD3255}" type="datetimeFigureOut">
              <a:rPr lang="zh-CN" altLang="en-US" smtClean="0"/>
              <a:t>2020/1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62F7272-86C5-4A8D-907D-1458538A5C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7E33A4D-3396-4958-AE13-885CF014D4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A8E92-9965-4940-924C-B83ED1544D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78882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4E46853-22AC-4088-956F-2FFB040EA3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F6D46E4-8975-4D04-A9CD-23E8B5218C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C460389-E21D-4607-9F0B-AD8F439532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D0C03-20F1-4EB4-836C-C2D697AD3255}" type="datetimeFigureOut">
              <a:rPr lang="zh-CN" altLang="en-US" smtClean="0"/>
              <a:t>2020/1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AA2BB96-5DEA-441A-921F-E8AECEA9AE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4939532-1C70-4874-91DE-1B8E7F22F3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A8E92-9965-4940-924C-B83ED1544D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9874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7BAD20-3E9D-44A9-9480-F028808833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EBDD947-B3D0-4575-A7AB-C5B9BE09A0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F7E67B9-F4D5-4572-8A25-4E1091D451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D0C03-20F1-4EB4-836C-C2D697AD3255}" type="datetimeFigureOut">
              <a:rPr lang="zh-CN" altLang="en-US" smtClean="0"/>
              <a:t>2020/1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C917FA9-13E6-4F30-A6CB-598FA3CDD4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D83FB54-8081-4B0D-9A05-EDA158480A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A8E92-9965-4940-924C-B83ED1544D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90637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B2CD3D8-27F7-4656-B568-2C47C1C3DE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D6326B6-3D9D-4310-A723-197AE7A866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0CF2B2A-6694-48C4-AFA0-5666EB3401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EEAA951-33BD-4A5F-BD13-06AB584448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D0C03-20F1-4EB4-836C-C2D697AD3255}" type="datetimeFigureOut">
              <a:rPr lang="zh-CN" altLang="en-US" smtClean="0"/>
              <a:t>2020/1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E51CD32-5A21-470E-98A9-2DB921C5E3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BFAF938-D874-47B8-A784-075B9B9F1F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A8E92-9965-4940-924C-B83ED1544D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1877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9A39028-304D-4AEF-85EA-46001154E4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F0C01E6-1312-482D-963C-2B8ABADDAC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837F13A-98CA-42CA-A63F-A65C27240A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5DFE3C0-8EC6-4D16-B305-B3F4DAAA28A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D673ECA-B92E-4E86-B8B4-7EBBD58408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877F4C6-08DD-4A20-A05B-07520F88D9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D0C03-20F1-4EB4-836C-C2D697AD3255}" type="datetimeFigureOut">
              <a:rPr lang="zh-CN" altLang="en-US" smtClean="0"/>
              <a:t>2020/12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FB2A3B8-3F26-4B5A-8049-34CE39EF9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B43D9AD-C1B9-4A89-9FE1-F9C36B40A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A8E92-9965-4940-924C-B83ED1544D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3832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87D06D3-1272-4E1F-A4C9-D0423639FA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82A1FA6-9909-4B15-9BFC-C38E909C4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D0C03-20F1-4EB4-836C-C2D697AD3255}" type="datetimeFigureOut">
              <a:rPr lang="zh-CN" altLang="en-US" smtClean="0"/>
              <a:t>2020/12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4352ADA-1F2B-436A-B591-EE96FB8136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1321DA7-9E30-4E5C-9CCA-21412135BE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A8E92-9965-4940-924C-B83ED1544D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85943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A8E9F04-D783-47D2-81DC-38341901B4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D0C03-20F1-4EB4-836C-C2D697AD3255}" type="datetimeFigureOut">
              <a:rPr lang="zh-CN" altLang="en-US" smtClean="0"/>
              <a:t>2020/12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E64FF48-F436-42A6-BEFF-EBD2CFE418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4F3A9AF-DE1D-448F-A9F6-20E36E091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A8E92-9965-4940-924C-B83ED1544D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22187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9A5A00C-B190-46A6-AFE5-1B79098C99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B8CEF3B-8E66-41C9-ADB1-97C746134D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A628045-4F34-41D0-8D29-416CA9A997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233E220-84CD-4CC4-8E2F-5D821BDBA7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D0C03-20F1-4EB4-836C-C2D697AD3255}" type="datetimeFigureOut">
              <a:rPr lang="zh-CN" altLang="en-US" smtClean="0"/>
              <a:t>2020/1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F9A36B6-A7B5-4109-B9F1-007740CD50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3BB5A22-C2B1-466C-BF6E-A5CBBC4183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A8E92-9965-4940-924C-B83ED1544D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47102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BFFFC7D-4968-4374-982C-8B9DB77D29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96E0C6B-A6DB-4030-BAAD-38B4D7EF684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817B24F-E8AA-49F9-A2DB-1177472B8C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01957F1-5CBC-4E2B-8731-AE7C751C6F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CD0C03-20F1-4EB4-836C-C2D697AD3255}" type="datetimeFigureOut">
              <a:rPr lang="zh-CN" altLang="en-US" smtClean="0"/>
              <a:t>2020/12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2E4ABC0-8FB2-48F1-AD1E-14E77AA0D6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399F185-9A9E-4049-9072-0B671D50BA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BA8E92-9965-4940-924C-B83ED1544D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47614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6381F3F-4593-413B-96D8-DB2F82B0CB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0DB88EB-CCD5-499A-B418-2A15B6F7A3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1F107AC-5D75-40EB-9FD2-3A062C3CA8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CD0C03-20F1-4EB4-836C-C2D697AD3255}" type="datetimeFigureOut">
              <a:rPr lang="zh-CN" altLang="en-US" smtClean="0"/>
              <a:t>2020/12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5401FAF-CF41-473C-8727-9ACF2310EF4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906B339-2607-42ED-B616-38D702D00E4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BA8E92-9965-4940-924C-B83ED1544D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6705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4.mp4"/><Relationship Id="rId1" Type="http://schemas.microsoft.com/office/2007/relationships/media" Target="../media/media4.mp4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5.mp4"/><Relationship Id="rId1" Type="http://schemas.microsoft.com/office/2007/relationships/media" Target="../media/media5.mp4"/><Relationship Id="rId4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5.mp4"/><Relationship Id="rId1" Type="http://schemas.microsoft.com/office/2007/relationships/media" Target="../media/media5.mp4"/><Relationship Id="rId4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Video TLR7 KO-LPS">
            <a:hlinkClick r:id="" action="ppaction://media"/>
            <a:extLst>
              <a:ext uri="{FF2B5EF4-FFF2-40B4-BE49-F238E27FC236}">
                <a16:creationId xmlns:a16="http://schemas.microsoft.com/office/drawing/2014/main" id="{72EEF5E1-1953-42E5-9A3F-A404B1ACB66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205990" y="225462"/>
            <a:ext cx="7498080" cy="617489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2CA77A02-4559-4BF6-B934-CAA1F849A971}"/>
              </a:ext>
            </a:extLst>
          </p:cNvPr>
          <p:cNvSpPr txBox="1"/>
          <p:nvPr/>
        </p:nvSpPr>
        <p:spPr>
          <a:xfrm>
            <a:off x="342900" y="617220"/>
            <a:ext cx="17107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LR7-KO-LPS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548392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6394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E265424-89A4-4B8E-A9F8-1E0AAA9FB8F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6055" y="150000"/>
            <a:ext cx="923988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92139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Video TLR7 KO-NS">
            <a:hlinkClick r:id="" action="ppaction://media"/>
            <a:extLst>
              <a:ext uri="{FF2B5EF4-FFF2-40B4-BE49-F238E27FC236}">
                <a16:creationId xmlns:a16="http://schemas.microsoft.com/office/drawing/2014/main" id="{28C80DE9-39C8-4A96-85BE-9060C8E90288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091690" y="324971"/>
            <a:ext cx="7509510" cy="6184302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C98068B8-2EF8-4DDF-9DAA-027923B160ED}"/>
              </a:ext>
            </a:extLst>
          </p:cNvPr>
          <p:cNvSpPr txBox="1"/>
          <p:nvPr/>
        </p:nvSpPr>
        <p:spPr>
          <a:xfrm>
            <a:off x="342900" y="617220"/>
            <a:ext cx="1582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LR7-KO-NS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3126428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2834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BE1581BA-D702-477E-92BB-A4437A3972C0}"/>
              </a:ext>
            </a:extLst>
          </p:cNvPr>
          <p:cNvSpPr txBox="1"/>
          <p:nvPr/>
        </p:nvSpPr>
        <p:spPr>
          <a:xfrm>
            <a:off x="342900" y="617220"/>
            <a:ext cx="1586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LR7-WT-NS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Video TLR7 WT-NS ">
            <a:hlinkClick r:id="" action="ppaction://media"/>
            <a:extLst>
              <a:ext uri="{FF2B5EF4-FFF2-40B4-BE49-F238E27FC236}">
                <a16:creationId xmlns:a16="http://schemas.microsoft.com/office/drawing/2014/main" id="{ADB9A98C-1440-491C-950E-2276210D52A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114550" y="150159"/>
            <a:ext cx="7738110" cy="63725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891718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7779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062C55B6-2215-4CEB-A17D-2765A87E92EE}"/>
              </a:ext>
            </a:extLst>
          </p:cNvPr>
          <p:cNvSpPr txBox="1"/>
          <p:nvPr/>
        </p:nvSpPr>
        <p:spPr>
          <a:xfrm>
            <a:off x="342900" y="617220"/>
            <a:ext cx="17876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LR7-cTG-LPS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Video TLR7-cTG-LPS">
            <a:hlinkClick r:id="" action="ppaction://media"/>
            <a:extLst>
              <a:ext uri="{FF2B5EF4-FFF2-40B4-BE49-F238E27FC236}">
                <a16:creationId xmlns:a16="http://schemas.microsoft.com/office/drawing/2014/main" id="{020A41E3-39D9-477D-9947-98B1DDE965D7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417989" y="400049"/>
            <a:ext cx="7594691" cy="62544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56836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517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D03AB31D-CFEF-4BB5-9EDD-E3CAD550D4F7}"/>
              </a:ext>
            </a:extLst>
          </p:cNvPr>
          <p:cNvSpPr txBox="1"/>
          <p:nvPr/>
        </p:nvSpPr>
        <p:spPr>
          <a:xfrm>
            <a:off x="342900" y="617220"/>
            <a:ext cx="920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-NS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Video WT-NS">
            <a:hlinkClick r:id="" action="ppaction://media"/>
            <a:extLst>
              <a:ext uri="{FF2B5EF4-FFF2-40B4-BE49-F238E27FC236}">
                <a16:creationId xmlns:a16="http://schemas.microsoft.com/office/drawing/2014/main" id="{6E31ADAE-3ABB-4AD4-A240-46BE44FB5757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965960" y="263785"/>
            <a:ext cx="7806690" cy="642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521315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110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D03AB31D-CFEF-4BB5-9EDD-E3CAD550D4F7}"/>
              </a:ext>
            </a:extLst>
          </p:cNvPr>
          <p:cNvSpPr txBox="1"/>
          <p:nvPr/>
        </p:nvSpPr>
        <p:spPr>
          <a:xfrm>
            <a:off x="342900" y="617220"/>
            <a:ext cx="9201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-NS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Video WT-NS">
            <a:hlinkClick r:id="" action="ppaction://media"/>
            <a:extLst>
              <a:ext uri="{FF2B5EF4-FFF2-40B4-BE49-F238E27FC236}">
                <a16:creationId xmlns:a16="http://schemas.microsoft.com/office/drawing/2014/main" id="{6E31ADAE-3ABB-4AD4-A240-46BE44FB5757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965960" y="263785"/>
            <a:ext cx="7806690" cy="642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114111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1100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60E3F451-7861-4B73-BBFB-562A368FD86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7425" y="0"/>
            <a:ext cx="923988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656107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7615BEDD-72E3-4F37-AC1B-83281434E70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3221" y="0"/>
            <a:ext cx="923988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875663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A6F3E5E-9EF6-4799-A979-6DBBF5DBC3E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6055" y="300000"/>
            <a:ext cx="923988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43767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6</Words>
  <Application>Microsoft Office PowerPoint</Application>
  <PresentationFormat>宽屏</PresentationFormat>
  <Paragraphs>6</Paragraphs>
  <Slides>10</Slides>
  <Notes>0</Notes>
  <HiddenSlides>0</HiddenSlides>
  <MMClips>6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5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 SY</dc:creator>
  <cp:lastModifiedBy>X SY</cp:lastModifiedBy>
  <cp:revision>1</cp:revision>
  <dcterms:created xsi:type="dcterms:W3CDTF">2020-12-07T08:48:55Z</dcterms:created>
  <dcterms:modified xsi:type="dcterms:W3CDTF">2020-12-07T08:53:38Z</dcterms:modified>
</cp:coreProperties>
</file>